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6613A85-0C23-8979-A924-5975293B078A}" name="Arina, Pietro" initials="AP" userId="S::rmhapa4@ucl.ac.uk::f73b2b68-e3e5-4427-8505-5c3808c331a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B3C"/>
    <a:srgbClr val="FFCF75"/>
    <a:srgbClr val="B6E1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3FCDB61-0D85-4F9E-99A3-AD23258C744D}" v="1" dt="2024-11-06T19:09:08.1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4" autoAdjust="0"/>
    <p:restoredTop sz="94660"/>
  </p:normalViewPr>
  <p:slideViewPr>
    <p:cSldViewPr snapToGrid="0">
      <p:cViewPr varScale="1">
        <p:scale>
          <a:sx n="129" d="100"/>
          <a:sy n="129" d="100"/>
        </p:scale>
        <p:origin x="108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rina, Pietro" userId="f73b2b68-e3e5-4427-8505-5c3808c331a9" providerId="ADAL" clId="{B3FCDB61-0D85-4F9E-99A3-AD23258C744D}"/>
    <pc:docChg chg="undo custSel delSld modSld">
      <pc:chgData name="Arina, Pietro" userId="f73b2b68-e3e5-4427-8505-5c3808c331a9" providerId="ADAL" clId="{B3FCDB61-0D85-4F9E-99A3-AD23258C744D}" dt="2024-11-06T19:09:11.272" v="56" actId="478"/>
      <pc:docMkLst>
        <pc:docMk/>
      </pc:docMkLst>
      <pc:sldChg chg="addSp delSp modSp mod">
        <pc:chgData name="Arina, Pietro" userId="f73b2b68-e3e5-4427-8505-5c3808c331a9" providerId="ADAL" clId="{B3FCDB61-0D85-4F9E-99A3-AD23258C744D}" dt="2024-11-06T19:09:02.480" v="52" actId="21"/>
        <pc:sldMkLst>
          <pc:docMk/>
          <pc:sldMk cId="863830823" sldId="256"/>
        </pc:sldMkLst>
        <pc:spChg chg="mod">
          <ac:chgData name="Arina, Pietro" userId="f73b2b68-e3e5-4427-8505-5c3808c331a9" providerId="ADAL" clId="{B3FCDB61-0D85-4F9E-99A3-AD23258C744D}" dt="2024-11-06T17:15:48.575" v="13" actId="20577"/>
          <ac:spMkLst>
            <pc:docMk/>
            <pc:sldMk cId="863830823" sldId="256"/>
            <ac:spMk id="3" creationId="{2FBB00B7-C295-DD37-3159-C63E68C55FE8}"/>
          </ac:spMkLst>
        </pc:spChg>
        <pc:spChg chg="add del mod">
          <ac:chgData name="Arina, Pietro" userId="f73b2b68-e3e5-4427-8505-5c3808c331a9" providerId="ADAL" clId="{B3FCDB61-0D85-4F9E-99A3-AD23258C744D}" dt="2024-11-06T19:09:02.480" v="52" actId="21"/>
          <ac:spMkLst>
            <pc:docMk/>
            <pc:sldMk cId="863830823" sldId="256"/>
            <ac:spMk id="5" creationId="{75D6A0EF-9926-DFB2-6A38-64A740CE4DAE}"/>
          </ac:spMkLst>
        </pc:spChg>
      </pc:sldChg>
      <pc:sldChg chg="del">
        <pc:chgData name="Arina, Pietro" userId="f73b2b68-e3e5-4427-8505-5c3808c331a9" providerId="ADAL" clId="{B3FCDB61-0D85-4F9E-99A3-AD23258C744D}" dt="2024-11-06T17:15:50.637" v="14" actId="47"/>
        <pc:sldMkLst>
          <pc:docMk/>
          <pc:sldMk cId="1582546284" sldId="271"/>
        </pc:sldMkLst>
      </pc:sldChg>
      <pc:sldChg chg="addSp delSp modSp mod">
        <pc:chgData name="Arina, Pietro" userId="f73b2b68-e3e5-4427-8505-5c3808c331a9" providerId="ADAL" clId="{B3FCDB61-0D85-4F9E-99A3-AD23258C744D}" dt="2024-11-06T19:09:11.272" v="56" actId="478"/>
        <pc:sldMkLst>
          <pc:docMk/>
          <pc:sldMk cId="2642891557" sldId="276"/>
        </pc:sldMkLst>
        <pc:spChg chg="del">
          <ac:chgData name="Arina, Pietro" userId="f73b2b68-e3e5-4427-8505-5c3808c331a9" providerId="ADAL" clId="{B3FCDB61-0D85-4F9E-99A3-AD23258C744D}" dt="2024-11-06T19:09:11.272" v="56" actId="478"/>
          <ac:spMkLst>
            <pc:docMk/>
            <pc:sldMk cId="2642891557" sldId="276"/>
            <ac:spMk id="2" creationId="{595EA26D-6514-C95A-1C3A-5FD7921547FE}"/>
          </ac:spMkLst>
        </pc:spChg>
        <pc:spChg chg="del mod">
          <ac:chgData name="Arina, Pietro" userId="f73b2b68-e3e5-4427-8505-5c3808c331a9" providerId="ADAL" clId="{B3FCDB61-0D85-4F9E-99A3-AD23258C744D}" dt="2024-11-06T19:08:37.874" v="43"/>
          <ac:spMkLst>
            <pc:docMk/>
            <pc:sldMk cId="2642891557" sldId="276"/>
            <ac:spMk id="3" creationId="{07432603-EF4F-21E7-3DD6-5B0BCE34B70C}"/>
          </ac:spMkLst>
        </pc:spChg>
        <pc:spChg chg="add mod">
          <ac:chgData name="Arina, Pietro" userId="f73b2b68-e3e5-4427-8505-5c3808c331a9" providerId="ADAL" clId="{B3FCDB61-0D85-4F9E-99A3-AD23258C744D}" dt="2024-11-06T19:09:08.148" v="55"/>
          <ac:spMkLst>
            <pc:docMk/>
            <pc:sldMk cId="2642891557" sldId="276"/>
            <ac:spMk id="9" creationId="{75D6A0EF-9926-DFB2-6A38-64A740CE4DAE}"/>
          </ac:spMkLst>
        </pc:spChg>
        <pc:picChg chg="mod">
          <ac:chgData name="Arina, Pietro" userId="f73b2b68-e3e5-4427-8505-5c3808c331a9" providerId="ADAL" clId="{B3FCDB61-0D85-4F9E-99A3-AD23258C744D}" dt="2024-11-06T19:09:07.532" v="54" actId="1076"/>
          <ac:picMkLst>
            <pc:docMk/>
            <pc:sldMk cId="2642891557" sldId="276"/>
            <ac:picMk id="5" creationId="{24AA6BA3-54B6-BEF3-1734-D33FD09B409D}"/>
          </ac:picMkLst>
        </pc:picChg>
      </pc:sldChg>
      <pc:sldChg chg="del">
        <pc:chgData name="Arina, Pietro" userId="f73b2b68-e3e5-4427-8505-5c3808c331a9" providerId="ADAL" clId="{B3FCDB61-0D85-4F9E-99A3-AD23258C744D}" dt="2024-11-06T17:15:51.478" v="15" actId="47"/>
        <pc:sldMkLst>
          <pc:docMk/>
          <pc:sldMk cId="4263733142" sldId="27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8A4003-2936-91B4-DAC1-29B8909C84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9D069E-1166-AD78-9425-8D37CACFE3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23ADFE-1E82-D3DF-70A1-1B7194D2A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CF1A54-6AD9-4901-A8DE-682CE32FB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A0BE9A-D37E-116B-7CB4-B90BCD97CE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406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A3DF64-8B62-D5AE-FE16-A236E3A98B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FF1B85-A6B8-F227-AA3E-C7AED396B6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01CA03-3EAF-9B8A-E410-107011D8D0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C07F98-4F41-83B6-3280-1275B6A9A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82F29B-7FE3-9B12-C805-6E348943F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951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3C5492-A2FC-8BC7-B9E7-F74E7B43B8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BE24EC-5D3F-4EF2-1075-7D21B333B4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63D1A3-8362-B232-4461-239EF96DD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7E5A82-8AAC-9AE3-A385-4220312BF4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AD88C6-51D8-C81F-E470-640ECE8DBC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346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DB3EBF-7809-17B9-6534-3847BA324B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BD0C3D-F4C9-C9A9-566E-B3D2D1E0E1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D697A9-45FF-BF95-8174-4ADCE8382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F441D3-5DC7-EED8-0314-87235D7E5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A4B397-63B3-AF1B-7639-5602393DD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75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13D86F-1FCF-BE31-9ACD-14D879E9A6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B771E0-E515-3B45-3844-1EDC993554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396425-9D31-6FCF-F5ED-AEB932FF9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79FD12-50B5-CFBD-7B6A-07AB5DC8AF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9CF55-4D87-860E-72B7-833CDE51C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682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1CB877-9A3E-24FB-9968-CD8A1BDFD8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C15527-E8CC-6286-E509-CC6A2B134EF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FB8162-72D7-B476-CF1B-875018428D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D440C3-C1AE-3475-902C-988DDDB5A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E1B356-C0D5-B9EA-0529-DACB3EF1B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6492F5-6772-07C9-DA92-389A82511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97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6F34FA-4648-00AA-6FB3-8C6D7A0E58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5DD6B2-8602-B8FE-BDC2-06F8B622C4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CD004C-4902-F48D-5096-E9A1793815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F77E3A2-39E1-533F-E1A2-71E3A4DEBF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96703E-B57D-E36B-A8D7-5667699D7E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AC349E-1B5D-F19E-2C31-5D6CD46EE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3D761C-34B9-3BF3-DD92-15E4D3051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F8866B6-137D-6266-02F4-BD70A73FA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706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FCE1D3-1DC4-BEEE-114F-8B9E2AFE4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A04502-0AEF-C903-F720-AFF14197E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8883CC-E188-CDD0-0425-E76FB9659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0E7297F-B375-49A8-FB21-9488FAE24A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136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53F70E9-D3EF-05FE-B3BC-2C28C4CE3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90EA4A7-9EB7-4544-6DEA-A39FC84421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55DCF4-3EE2-EED5-19B5-2F0F48131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483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8CA3F6-A3BE-7B30-D98B-C21EDDDE9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5C37B61-0E64-165F-BB19-36AEEE49B0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5AB471-C689-CBCD-E964-28BFA76864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27358D-C257-936F-FE52-1A50EEACC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ACE66F-4613-B0E9-CD3D-072BE7183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CBE54A-EF65-7BE1-8B5B-18C2EEF14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314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BC1351-C7E3-AA96-CE31-2CC8344C08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EBCEB2-C3F6-EAE8-61BB-2E5342F2D6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1CD706-A693-BB59-360F-1E88CB854E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46E9D7-F825-9070-EE80-7F75E5F20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1E5718-E937-606F-B5AB-4E908C4A9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F3DE2A-DFF8-DC64-35BE-2C84C847D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3744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3F5B686-27DF-B078-1D81-4EA9931B66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7FE5F5-E33A-2299-5023-3864B9A05E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4C8910-C00E-1BB4-7189-65225A0036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8BFA07-5371-4561-A87A-5BE59663A7D6}" type="datetimeFigureOut">
              <a:rPr lang="en-US" smtClean="0"/>
              <a:t>11/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1E73D7-9A55-F353-29DD-673CA6F877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C139F9-B98D-58FF-411D-1CA9A644B3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1C7CA0-BD56-44ED-AF77-7E83A11517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6202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A72E8-32ED-B2AD-C743-C93FAD69753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Bef>
                <a:spcPts val="1200"/>
              </a:spcBef>
            </a:pPr>
            <a:r>
              <a:rPr lang="en-GB" sz="1800" b="1" kern="0" dirty="0">
                <a:solidFill>
                  <a:srgbClr val="2F5496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abolic flexibility as a candidate mechanism for the development of postoperative morbidity</a:t>
            </a:r>
            <a:br>
              <a:rPr lang="en-GB" sz="1800" b="1" kern="0" dirty="0">
                <a:solidFill>
                  <a:srgbClr val="2F5496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GB" sz="1800" b="1" kern="0" dirty="0">
                <a:solidFill>
                  <a:srgbClr val="2F5496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US" sz="1800" b="1" kern="0" dirty="0">
                <a:solidFill>
                  <a:srgbClr val="2F5496"/>
                </a:solidFill>
                <a:effectLst/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</a:br>
            <a:b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BB00B7-C295-DD37-3159-C63E68C55FE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/>
              <a:t>Supplementary Figure legend in main manuscrip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38308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graph of colored lines&#10;&#10;Description automatically generated">
            <a:extLst>
              <a:ext uri="{FF2B5EF4-FFF2-40B4-BE49-F238E27FC236}">
                <a16:creationId xmlns:a16="http://schemas.microsoft.com/office/drawing/2014/main" id="{24AA6BA3-54B6-BEF3-1734-D33FD09B409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002" y="254169"/>
            <a:ext cx="10593466" cy="5804640"/>
          </a:xfrm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979D5C02-F3FA-4BD4-CFD5-DE8649F01EA2}"/>
              </a:ext>
            </a:extLst>
          </p:cNvPr>
          <p:cNvGrpSpPr/>
          <p:nvPr/>
        </p:nvGrpSpPr>
        <p:grpSpPr>
          <a:xfrm>
            <a:off x="3858883" y="365125"/>
            <a:ext cx="3364679" cy="315378"/>
            <a:chOff x="3858883" y="365125"/>
            <a:chExt cx="3364679" cy="315378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07FC0918-2232-734A-07FA-C12595D7BB20}"/>
                </a:ext>
              </a:extLst>
            </p:cNvPr>
            <p:cNvSpPr/>
            <p:nvPr/>
          </p:nvSpPr>
          <p:spPr>
            <a:xfrm>
              <a:off x="4012020" y="481034"/>
              <a:ext cx="305764" cy="103152"/>
            </a:xfrm>
            <a:prstGeom prst="rect">
              <a:avLst/>
            </a:prstGeom>
            <a:solidFill>
              <a:srgbClr val="B6E1F3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16A77FCA-3763-B16D-6709-932547F2ADE4}"/>
                </a:ext>
              </a:extLst>
            </p:cNvPr>
            <p:cNvSpPr/>
            <p:nvPr/>
          </p:nvSpPr>
          <p:spPr>
            <a:xfrm>
              <a:off x="5110805" y="481034"/>
              <a:ext cx="305764" cy="126012"/>
            </a:xfrm>
            <a:prstGeom prst="rect">
              <a:avLst/>
            </a:prstGeom>
            <a:solidFill>
              <a:srgbClr val="FFCF75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91CC6049-69DD-EA29-D898-E8BCD4B29675}"/>
                </a:ext>
              </a:extLst>
            </p:cNvPr>
            <p:cNvSpPr/>
            <p:nvPr/>
          </p:nvSpPr>
          <p:spPr>
            <a:xfrm>
              <a:off x="6093853" y="475354"/>
              <a:ext cx="305765" cy="126012"/>
            </a:xfrm>
            <a:prstGeom prst="rect">
              <a:avLst/>
            </a:prstGeom>
            <a:solidFill>
              <a:srgbClr val="FF6B3C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D562528-3A60-27A7-F356-7F689878431E}"/>
                </a:ext>
              </a:extLst>
            </p:cNvPr>
            <p:cNvSpPr txBox="1"/>
            <p:nvPr/>
          </p:nvSpPr>
          <p:spPr>
            <a:xfrm>
              <a:off x="4289746" y="394110"/>
              <a:ext cx="8210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POMS 0/1</a:t>
              </a:r>
              <a:endParaRPr lang="en-US" sz="12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DC3E61C-216E-DA53-75EB-DA242F2F1457}"/>
                </a:ext>
              </a:extLst>
            </p:cNvPr>
            <p:cNvSpPr txBox="1"/>
            <p:nvPr/>
          </p:nvSpPr>
          <p:spPr>
            <a:xfrm>
              <a:off x="5406859" y="365125"/>
              <a:ext cx="7008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POMS</a:t>
              </a:r>
              <a:r>
                <a:rPr lang="en-GB" sz="1400" dirty="0"/>
                <a:t> </a:t>
              </a:r>
              <a:r>
                <a:rPr lang="en-GB" sz="1200" dirty="0"/>
                <a:t>2</a:t>
              </a:r>
              <a:endParaRPr lang="en-US" sz="1400" dirty="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67BE43D-D4DE-21F9-F822-517224C936B3}"/>
                </a:ext>
              </a:extLst>
            </p:cNvPr>
            <p:cNvSpPr txBox="1"/>
            <p:nvPr/>
          </p:nvSpPr>
          <p:spPr>
            <a:xfrm>
              <a:off x="6402503" y="394109"/>
              <a:ext cx="8210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POMS 3/6</a:t>
              </a:r>
              <a:endParaRPr lang="en-US" sz="1200" dirty="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ABD5C876-95D9-CD93-F5AA-BACE4B8D7C6F}"/>
                </a:ext>
              </a:extLst>
            </p:cNvPr>
            <p:cNvSpPr/>
            <p:nvPr/>
          </p:nvSpPr>
          <p:spPr>
            <a:xfrm>
              <a:off x="3858883" y="394108"/>
              <a:ext cx="3364679" cy="28639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75D6A0EF-9926-DFB2-6A38-64A740CE4DAE}"/>
              </a:ext>
            </a:extLst>
          </p:cNvPr>
          <p:cNvSpPr txBox="1"/>
          <p:nvPr/>
        </p:nvSpPr>
        <p:spPr>
          <a:xfrm>
            <a:off x="379140" y="5777034"/>
            <a:ext cx="11634439" cy="8819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Time-Dependent VO2/Kg/min in CPET</a:t>
            </a:r>
            <a:endParaRPr lang="it-I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lots the % of time (x-axis) against VO2/Kg/min (ml/kg/min) (y-axis) for all CPET, categorizing patients by colour: POMS 0-1 - Light Blue, POMS 2 - Orange, POMS 3-6 - Red.</a:t>
            </a:r>
            <a:endParaRPr lang="it-IT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28915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6</TotalTime>
  <Words>89</Words>
  <Application>Microsoft Office PowerPoint</Application>
  <PresentationFormat>Widescreen</PresentationFormat>
  <Paragraphs>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Metabolic flexibility as a candidate mechanism for the development of postoperative morbidity    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ina, Pietro</dc:creator>
  <cp:lastModifiedBy>Arina, Pietro</cp:lastModifiedBy>
  <cp:revision>4</cp:revision>
  <dcterms:created xsi:type="dcterms:W3CDTF">2023-09-05T09:43:48Z</dcterms:created>
  <dcterms:modified xsi:type="dcterms:W3CDTF">2024-11-06T19:09:12Z</dcterms:modified>
</cp:coreProperties>
</file>